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11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102" y="16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C5AC1-AF75-4135-8DC1-7D420E864A20}" type="datetimeFigureOut">
              <a:rPr lang="ko-KR" altLang="en-US" smtClean="0"/>
              <a:t>2017-03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55F43-EB83-4FDB-B146-910ABEEC36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7086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C5AC1-AF75-4135-8DC1-7D420E864A20}" type="datetimeFigureOut">
              <a:rPr lang="ko-KR" altLang="en-US" smtClean="0"/>
              <a:t>2017-03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55F43-EB83-4FDB-B146-910ABEEC36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6120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C5AC1-AF75-4135-8DC1-7D420E864A20}" type="datetimeFigureOut">
              <a:rPr lang="ko-KR" altLang="en-US" smtClean="0"/>
              <a:t>2017-03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55F43-EB83-4FDB-B146-910ABEEC36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4847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C5AC1-AF75-4135-8DC1-7D420E864A20}" type="datetimeFigureOut">
              <a:rPr lang="ko-KR" altLang="en-US" smtClean="0"/>
              <a:t>2017-03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55F43-EB83-4FDB-B146-910ABEEC36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2425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C5AC1-AF75-4135-8DC1-7D420E864A20}" type="datetimeFigureOut">
              <a:rPr lang="ko-KR" altLang="en-US" smtClean="0"/>
              <a:t>2017-03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55F43-EB83-4FDB-B146-910ABEEC36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7423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C5AC1-AF75-4135-8DC1-7D420E864A20}" type="datetimeFigureOut">
              <a:rPr lang="ko-KR" altLang="en-US" smtClean="0"/>
              <a:t>2017-03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55F43-EB83-4FDB-B146-910ABEEC36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43691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C5AC1-AF75-4135-8DC1-7D420E864A20}" type="datetimeFigureOut">
              <a:rPr lang="ko-KR" altLang="en-US" smtClean="0"/>
              <a:t>2017-03-0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55F43-EB83-4FDB-B146-910ABEEC36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9950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C5AC1-AF75-4135-8DC1-7D420E864A20}" type="datetimeFigureOut">
              <a:rPr lang="ko-KR" altLang="en-US" smtClean="0"/>
              <a:t>2017-03-0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55F43-EB83-4FDB-B146-910ABEEC36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6368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C5AC1-AF75-4135-8DC1-7D420E864A20}" type="datetimeFigureOut">
              <a:rPr lang="ko-KR" altLang="en-US" smtClean="0"/>
              <a:t>2017-03-0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55F43-EB83-4FDB-B146-910ABEEC36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8665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C5AC1-AF75-4135-8DC1-7D420E864A20}" type="datetimeFigureOut">
              <a:rPr lang="ko-KR" altLang="en-US" smtClean="0"/>
              <a:t>2017-03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55F43-EB83-4FDB-B146-910ABEEC36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6838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C5AC1-AF75-4135-8DC1-7D420E864A20}" type="datetimeFigureOut">
              <a:rPr lang="ko-KR" altLang="en-US" smtClean="0"/>
              <a:t>2017-03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55F43-EB83-4FDB-B146-910ABEEC36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9121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C5AC1-AF75-4135-8DC1-7D420E864A20}" type="datetimeFigureOut">
              <a:rPr lang="ko-KR" altLang="en-US" smtClean="0"/>
              <a:t>2017-03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755F43-EB83-4FDB-B146-910ABEEC36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3308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표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2629542"/>
              </p:ext>
            </p:extLst>
          </p:nvPr>
        </p:nvGraphicFramePr>
        <p:xfrm>
          <a:off x="1039941" y="350370"/>
          <a:ext cx="4990744" cy="46989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39555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8387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8387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2744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93685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</a:pPr>
                      <a:r>
                        <a:rPr lang="en-US" altLang="ko-KR" sz="1050" b="1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otal population</a:t>
                      </a:r>
                      <a:endParaRPr lang="ko-KR" sz="105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 (n=51)</a:t>
                      </a:r>
                      <a:endParaRPr lang="ko-KR" sz="105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CB (n=24)</a:t>
                      </a:r>
                      <a:endParaRPr lang="ko-KR" sz="105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ko-KR" sz="105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jor adverse cardiac event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25.5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25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-cause death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3.9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  <a:endParaRPr lang="ko-KR" sz="9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c death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)</a:t>
                      </a:r>
                      <a:endParaRPr lang="ko-KR" sz="9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  <a:endParaRPr lang="ko-KR" sz="9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fatal myocardial infarction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  <a:endParaRPr lang="ko-KR" sz="9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lesion revascularization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21.6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6.7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onary artery bypass graft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3.9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2.5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nt thrombosis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3.9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altLang="ko-KR" sz="105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fter propensity score matching</a:t>
                      </a:r>
                      <a:endParaRPr kumimoji="0" lang="ko-KR" altLang="en-US" sz="1050" b="1" i="0" u="none" strike="noStrike" kern="10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 (</a:t>
                      </a:r>
                      <a:r>
                        <a:rPr lang="en-GB" sz="1050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24)</a:t>
                      </a:r>
                      <a:endParaRPr lang="ko-KR" sz="105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CB (n=24)</a:t>
                      </a:r>
                      <a:endParaRPr lang="ko-KR" sz="105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ko-KR" sz="1050" b="1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6902587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jor adverse cardiac event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 (29.2)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 (25)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75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84735924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-cause death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4.2)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0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38540564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c death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4.2)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0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77261166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fatal myocardial infarction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4.2)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0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99618998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lesion revascularization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 (20.8)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 (16.7)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0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10095805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onary artery bypass graft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 (8.3)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 (12.5)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0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69205801"/>
                  </a:ext>
                </a:extLst>
              </a:tr>
              <a:tr h="293685"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nt thrombosis, n (%)</a:t>
                      </a:r>
                      <a:endParaRPr lang="ko-KR" sz="9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 (4.2)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050" kern="100" dirty="0" smtClean="0"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0</a:t>
                      </a:r>
                      <a:endParaRPr lang="ko-KR" sz="105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6172751"/>
                  </a:ext>
                </a:extLst>
              </a:tr>
            </a:tbl>
          </a:graphicData>
        </a:graphic>
      </p:graphicFrame>
      <p:sp>
        <p:nvSpPr>
          <p:cNvPr id="47" name="TextBox 46"/>
          <p:cNvSpPr txBox="1"/>
          <p:nvPr/>
        </p:nvSpPr>
        <p:spPr>
          <a:xfrm>
            <a:off x="623314" y="141917"/>
            <a:ext cx="6473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623314" y="5119862"/>
            <a:ext cx="6473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그림 4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9941" y="5248241"/>
            <a:ext cx="4722206" cy="44946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6672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210</Words>
  <Application>Microsoft Office PowerPoint</Application>
  <PresentationFormat>A4 용지(210x297mm)</PresentationFormat>
  <Paragraphs>66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CA-JHJ</cp:lastModifiedBy>
  <cp:revision>7</cp:revision>
  <dcterms:created xsi:type="dcterms:W3CDTF">2017-01-22T11:52:21Z</dcterms:created>
  <dcterms:modified xsi:type="dcterms:W3CDTF">2017-03-09T04:45:10Z</dcterms:modified>
</cp:coreProperties>
</file>